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7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A682C-0053-4A1B-ACF2-6B126DCC510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CB9A8-A045-4B76-92DD-75F1698192AE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935118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A682C-0053-4A1B-ACF2-6B126DCC510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CB9A8-A045-4B76-92DD-75F1698192AE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5526402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A682C-0053-4A1B-ACF2-6B126DCC510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CB9A8-A045-4B76-92DD-75F1698192AE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921036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A682C-0053-4A1B-ACF2-6B126DCC510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CB9A8-A045-4B76-92DD-75F1698192AE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17042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A682C-0053-4A1B-ACF2-6B126DCC510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CB9A8-A045-4B76-92DD-75F1698192AE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58273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A682C-0053-4A1B-ACF2-6B126DCC510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CB9A8-A045-4B76-92DD-75F1698192AE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70703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A682C-0053-4A1B-ACF2-6B126DCC510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CB9A8-A045-4B76-92DD-75F1698192AE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706918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A682C-0053-4A1B-ACF2-6B126DCC510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CB9A8-A045-4B76-92DD-75F1698192AE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868529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A682C-0053-4A1B-ACF2-6B126DCC510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CB9A8-A045-4B76-92DD-75F1698192AE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713923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A682C-0053-4A1B-ACF2-6B126DCC510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CB9A8-A045-4B76-92DD-75F1698192AE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359430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A682C-0053-4A1B-ACF2-6B126DCC510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CB9A8-A045-4B76-92DD-75F1698192AE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699628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A682C-0053-4A1B-ACF2-6B126DCC510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BCB9A8-A045-4B76-92DD-75F1698192AE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930516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jpeg"/><Relationship Id="rId7" Type="http://schemas.openxmlformats.org/officeDocument/2006/relationships/image" Target="../media/image9.jpe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jpe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0" y="0"/>
            <a:ext cx="5004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: Figure S1A</a:t>
            </a:r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Induced differentiation of MSCs.</a:t>
            </a:r>
            <a:endParaRPr lang="de-A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259632" y="476672"/>
            <a:ext cx="74888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A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ipocytes</a:t>
            </a:r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</a:t>
            </a:r>
            <a:r>
              <a:rPr lang="de-A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steocytes</a:t>
            </a:r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</a:t>
            </a:r>
            <a:r>
              <a:rPr lang="de-A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ondrocytes</a:t>
            </a:r>
            <a:endParaRPr lang="de-A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90407" y="3284984"/>
            <a:ext cx="855809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/>
            <a:r>
              <a:rPr lang="de-A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A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egend</a:t>
            </a:r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A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TERT</a:t>
            </a:r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SCs may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velop into adipocytes, osteocytes 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hondrocyte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croscopy pictures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ffect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spective cell culture differentiatio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diums on MSC cell line. S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cific </a:t>
            </a:r>
            <a:r>
              <a:rPr lang="en-US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inings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ith Oil Red 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 (for adipocytes),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izarin Red S 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osteocytes) and </a:t>
            </a:r>
            <a:r>
              <a:rPr lang="en-US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luidin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 (chondrocytes)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re performed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ell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regularly observed under the microscope, photos were taken at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4 day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culture. Pictures a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ative dat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dependent experiments. </a:t>
            </a:r>
            <a:endParaRPr lang="de-A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6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4891" y="908720"/>
            <a:ext cx="2808495" cy="2250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8189" y="908720"/>
            <a:ext cx="2782534" cy="2250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0868" y="908720"/>
            <a:ext cx="2801989" cy="2250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4498772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-1" y="0"/>
            <a:ext cx="7164289" cy="374927"/>
          </a:xfrm>
        </p:spPr>
        <p:txBody>
          <a:bodyPr>
            <a:normAutofit fontScale="90000"/>
          </a:bodyPr>
          <a:lstStyle/>
          <a:p>
            <a:pPr algn="l"/>
            <a:r>
              <a:rPr lang="de-AT" sz="1400" dirty="0" smtClean="0">
                <a:latin typeface="Arial" pitchFamily="34" charset="0"/>
                <a:cs typeface="Arial" pitchFamily="34" charset="0"/>
              </a:rPr>
              <a:t>Additional file 1: </a:t>
            </a:r>
            <a:r>
              <a:rPr lang="de-AT" sz="1400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de-AT" sz="1400" dirty="0" smtClean="0">
                <a:latin typeface="Arial" pitchFamily="34" charset="0"/>
                <a:cs typeface="Arial" pitchFamily="34" charset="0"/>
              </a:rPr>
              <a:t>S1B</a:t>
            </a:r>
            <a:r>
              <a:rPr lang="de-AT" sz="1400" dirty="0" smtClean="0">
                <a:latin typeface="Arial" pitchFamily="34" charset="0"/>
                <a:cs typeface="Arial" pitchFamily="34" charset="0"/>
              </a:rPr>
              <a:t>. Spontaneous adipocyte differentiation of primary stromal cells.</a:t>
            </a:r>
            <a:endParaRPr lang="de-AT" sz="14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9" name="Group 18"/>
          <p:cNvGrpSpPr/>
          <p:nvPr/>
        </p:nvGrpSpPr>
        <p:grpSpPr>
          <a:xfrm>
            <a:off x="282758" y="384193"/>
            <a:ext cx="8559515" cy="5966470"/>
            <a:chOff x="282758" y="509185"/>
            <a:chExt cx="8559515" cy="596647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9522" y="816965"/>
              <a:ext cx="3278775" cy="2606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9" name="Picture 7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85995" y="3844445"/>
              <a:ext cx="3230626" cy="2631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7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51869" y="4563330"/>
              <a:ext cx="2390403" cy="1912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8" name="Picture 37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2758" y="3844444"/>
              <a:ext cx="3305540" cy="2631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6" name="Picture 5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52465" y="4563330"/>
              <a:ext cx="2403336" cy="1912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5" name="Picture 5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85251" y="816965"/>
              <a:ext cx="3231370" cy="26145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0" name="Picture 39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51869" y="1504767"/>
              <a:ext cx="2390403" cy="19267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" name="Picture 3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52465" y="1504767"/>
              <a:ext cx="2403336" cy="1918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1525338" y="509186"/>
              <a:ext cx="1080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moxia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5940897" y="509185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arvation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692425" y="3533101"/>
              <a:ext cx="1080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ypoxia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616861" y="3533101"/>
              <a:ext cx="16921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de-AT" sz="12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poxia</a:t>
              </a:r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de-AT" sz="12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arvation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685996" y="3176861"/>
              <a:ext cx="5738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 µm</a:t>
              </a:r>
              <a:endParaRPr lang="de-AT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82758" y="6227553"/>
              <a:ext cx="5421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AT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 µm</a:t>
              </a: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309523" y="3176860"/>
              <a:ext cx="5421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AT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 µm</a:t>
              </a: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4685624" y="6227552"/>
              <a:ext cx="5421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AT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 µm</a:t>
              </a:r>
            </a:p>
          </p:txBody>
        </p:sp>
        <p:cxnSp>
          <p:nvCxnSpPr>
            <p:cNvPr id="27" name="Straight Connector 26"/>
            <p:cNvCxnSpPr/>
            <p:nvPr/>
          </p:nvCxnSpPr>
          <p:spPr>
            <a:xfrm>
              <a:off x="4827709" y="6248966"/>
              <a:ext cx="22460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4860614" y="3221465"/>
              <a:ext cx="22460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433996" y="6247785"/>
              <a:ext cx="22460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467108" y="3213450"/>
              <a:ext cx="22460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8194201" y="1609053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de-AT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 µm</a:t>
              </a:r>
              <a:endParaRPr lang="de-AT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8241312" y="4645394"/>
              <a:ext cx="5421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AT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de-AT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de-AT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µm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3843133" y="1616256"/>
              <a:ext cx="5421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AT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de-AT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de-AT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µm</a:t>
              </a:r>
            </a:p>
          </p:txBody>
        </p:sp>
        <p:sp>
          <p:nvSpPr>
            <p:cNvPr id="41" name="Rectangle 40"/>
            <p:cNvSpPr/>
            <p:nvPr/>
          </p:nvSpPr>
          <p:spPr>
            <a:xfrm>
              <a:off x="3872552" y="4644511"/>
              <a:ext cx="5421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AT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de-AT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de-AT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µm</a:t>
              </a:r>
            </a:p>
          </p:txBody>
        </p:sp>
        <p:cxnSp>
          <p:nvCxnSpPr>
            <p:cNvPr id="32" name="Straight Connector 31"/>
            <p:cNvCxnSpPr/>
            <p:nvPr/>
          </p:nvCxnSpPr>
          <p:spPr>
            <a:xfrm>
              <a:off x="3980495" y="4633389"/>
              <a:ext cx="4320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8317435" y="4644511"/>
              <a:ext cx="4320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8302213" y="1614808"/>
              <a:ext cx="4320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3948207" y="1627210"/>
              <a:ext cx="4320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TextBox 19"/>
          <p:cNvSpPr txBox="1"/>
          <p:nvPr/>
        </p:nvSpPr>
        <p:spPr>
          <a:xfrm>
            <a:off x="142715" y="6391792"/>
            <a:ext cx="88937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Legend. </a:t>
            </a:r>
            <a:r>
              <a:rPr lang="de-AT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stromal cells were stained with Oil Red O to detect adipocyte differentiation. Photos were taken at day 21 in culture. Pictures are representative of 4 independent experiments.</a:t>
            </a:r>
            <a:endParaRPr lang="de-AT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28241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6</Words>
  <Application>Microsoft Office PowerPoint</Application>
  <PresentationFormat>On-screen Show (4:3)</PresentationFormat>
  <Paragraphs>1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Additional file 1: Figure S1B. Spontaneous adipocyte differentiation of primary stromal cells.</vt:lpstr>
    </vt:vector>
  </TitlesOfParts>
  <Company>stan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sak Zvenyslava</dc:creator>
  <cp:lastModifiedBy>Husak Zvenyslava</cp:lastModifiedBy>
  <cp:revision>13</cp:revision>
  <dcterms:created xsi:type="dcterms:W3CDTF">2014-06-23T14:08:58Z</dcterms:created>
  <dcterms:modified xsi:type="dcterms:W3CDTF">2016-10-19T11:49:17Z</dcterms:modified>
</cp:coreProperties>
</file>